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09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4922">
          <p15:clr>
            <a:srgbClr val="A4A3A4"/>
          </p15:clr>
        </p15:guide>
        <p15:guide id="4" pos="39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ulie Aspden" initials="" lastIdx="1" clrIdx="0"/>
  <p:cmAuthor id="1" name="Julie Aspden" initials="JA" lastIdx="18" clrIdx="1">
    <p:extLst>
      <p:ext uri="{19B8F6BF-5375-455C-9EA6-DF929625EA0E}">
        <p15:presenceInfo xmlns:p15="http://schemas.microsoft.com/office/powerpoint/2012/main" userId="S::fbsjas@leeds.ac.uk::647d6aff-221e-4d07-9989-160857ddfb47" providerId="AD"/>
      </p:ext>
    </p:extLst>
  </p:cmAuthor>
  <p:cmAuthor id="2" name="Juan Fontana Jordan De Urries" initials="JFJDU" lastIdx="10" clrIdx="2">
    <p:extLst>
      <p:ext uri="{19B8F6BF-5375-455C-9EA6-DF929625EA0E}">
        <p15:presenceInfo xmlns:p15="http://schemas.microsoft.com/office/powerpoint/2012/main" userId="S::fbsjfo@leeds.ac.uk::3462a2bb-b037-4c0e-aa18-b1f8427319b3" providerId="AD"/>
      </p:ext>
    </p:extLst>
  </p:cmAuthor>
  <p:cmAuthor id="3" name="Karl Norris" initials="KN" lastIdx="6" clrIdx="3">
    <p:extLst>
      <p:ext uri="{19B8F6BF-5375-455C-9EA6-DF929625EA0E}">
        <p15:presenceInfo xmlns:p15="http://schemas.microsoft.com/office/powerpoint/2012/main" userId="Karl Norris" providerId="None"/>
      </p:ext>
    </p:extLst>
  </p:cmAuthor>
  <p:cmAuthor id="4" name="Tayah Hopes" initials="TH" lastIdx="2" clrIdx="4">
    <p:extLst>
      <p:ext uri="{19B8F6BF-5375-455C-9EA6-DF929625EA0E}">
        <p15:presenceInfo xmlns:p15="http://schemas.microsoft.com/office/powerpoint/2012/main" userId="S::fbstsho@leeds.ac.uk::4d3ff96e-e068-4a11-9e61-a469e3977832" providerId="AD"/>
      </p:ext>
    </p:extLst>
  </p:cmAuthor>
  <p:cmAuthor id="5" name="Karl Norris" initials="KN [2]" lastIdx="1" clrIdx="5">
    <p:extLst>
      <p:ext uri="{19B8F6BF-5375-455C-9EA6-DF929625EA0E}">
        <p15:presenceInfo xmlns:p15="http://schemas.microsoft.com/office/powerpoint/2012/main" userId="S::fbskn@leeds.ac.uk::8ae02d21-a200-4823-b6f3-444a95ac573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9193"/>
    <a:srgbClr val="F67A26"/>
    <a:srgbClr val="FEC623"/>
    <a:srgbClr val="4273CA"/>
    <a:srgbClr val="16B050"/>
    <a:srgbClr val="2E5290"/>
    <a:srgbClr val="00FDFF"/>
    <a:srgbClr val="00FA00"/>
    <a:srgbClr val="73FB79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584" y="184"/>
      </p:cViewPr>
      <p:guideLst>
        <p:guide orient="horz" pos="3120"/>
        <p:guide pos="2160"/>
        <p:guide orient="horz" pos="4922"/>
        <p:guide pos="39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0DBE6-65EC-412A-92B9-0C94CCC51376}" type="datetimeFigureOut">
              <a:rPr lang="en-US"/>
              <a:t>5/2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75935-0359-4C45-8C27-115463D3B7CD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143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975935-0359-4C45-8C27-115463D3B7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4366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4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2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0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562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7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2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29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8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389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72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097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99A19-9056-D447-BB4E-DDBAAB2AAE1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9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A7AC74F-5168-1F41-8EED-EC3FD7FC93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8798" y="82680"/>
            <a:ext cx="3191650" cy="386945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3738439-FD85-074E-8FC5-D21302826EE2}"/>
              </a:ext>
            </a:extLst>
          </p:cNvPr>
          <p:cNvSpPr txBox="1"/>
          <p:nvPr/>
        </p:nvSpPr>
        <p:spPr>
          <a:xfrm>
            <a:off x="217606" y="6341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E69E1D-16C6-C244-B513-94A9F52E84F0}"/>
              </a:ext>
            </a:extLst>
          </p:cNvPr>
          <p:cNvSpPr txBox="1"/>
          <p:nvPr/>
        </p:nvSpPr>
        <p:spPr>
          <a:xfrm>
            <a:off x="3183390" y="10097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5A8E04E-38FC-F645-9D94-B32CFE8816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4141" y="82679"/>
            <a:ext cx="3183859" cy="386945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829C6A3-3A55-4548-BA92-76F033DD4AC7}"/>
              </a:ext>
            </a:extLst>
          </p:cNvPr>
          <p:cNvSpPr txBox="1"/>
          <p:nvPr/>
        </p:nvSpPr>
        <p:spPr>
          <a:xfrm>
            <a:off x="5852072" y="122520"/>
            <a:ext cx="6992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Sup 5</a:t>
            </a:r>
          </a:p>
          <a:p>
            <a:endParaRPr lang="en-US">
              <a:latin typeface="+mj-lt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192EB03-4A98-314B-A957-1374B34CD321}"/>
              </a:ext>
            </a:extLst>
          </p:cNvPr>
          <p:cNvSpPr txBox="1"/>
          <p:nvPr/>
        </p:nvSpPr>
        <p:spPr>
          <a:xfrm>
            <a:off x="128160" y="3980783"/>
            <a:ext cx="3080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  <a:p>
            <a:endParaRPr lang="en-US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077D6A7-67C2-AA43-BD56-4BF8CED7C5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9686" y="4397708"/>
            <a:ext cx="2006432" cy="2304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F03DA19-3F5B-AC48-8C3E-37F7FE8D394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88758" y="4397708"/>
            <a:ext cx="2000690" cy="2304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0A20DAB-C807-A34E-892A-C9A590BF42D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84281" y="4397708"/>
            <a:ext cx="2024609" cy="2304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CB7C41C-33A5-C946-95E5-475C994249A4}"/>
              </a:ext>
            </a:extLst>
          </p:cNvPr>
          <p:cNvSpPr txBox="1"/>
          <p:nvPr/>
        </p:nvSpPr>
        <p:spPr>
          <a:xfrm>
            <a:off x="2358457" y="3980783"/>
            <a:ext cx="3273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  <a:p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E63B7D-D4CD-1A46-A7FB-785B2F7918B1}"/>
              </a:ext>
            </a:extLst>
          </p:cNvPr>
          <p:cNvSpPr txBox="1"/>
          <p:nvPr/>
        </p:nvSpPr>
        <p:spPr>
          <a:xfrm>
            <a:off x="4530695" y="3980783"/>
            <a:ext cx="2968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</a:t>
            </a:r>
          </a:p>
          <a:p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CE66811-0E3C-0B4C-A94B-2B9AF8A1D54A}"/>
              </a:ext>
            </a:extLst>
          </p:cNvPr>
          <p:cNvSpPr/>
          <p:nvPr/>
        </p:nvSpPr>
        <p:spPr>
          <a:xfrm>
            <a:off x="282209" y="7115452"/>
            <a:ext cx="6269093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 5: Gonad ribosome heterogeneity through paralog enrichment and paralog-switching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erarchical clustering of log</a:t>
            </a:r>
            <a:r>
              <a:rPr lang="en-US" sz="1100" baseline="-25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rmalised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bundances from (A) TMT replicate 1 and (B) TMT replicate 3, clustered according to row. (C-E) Volcano plots highlighting little change detected by TMT-MS in the enrichment of RPs when comparing 80S from embryo to (C) testis, (D) head or (E) ovary tissue. </a:t>
            </a:r>
            <a:endParaRPr lang="en-GB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1332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83</Words>
  <Application>Microsoft Macintosh PowerPoint</Application>
  <PresentationFormat>A4 Paper (210x297 mm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Aspden</dc:creator>
  <cp:lastModifiedBy>Julie Aspden</cp:lastModifiedBy>
  <cp:revision>3</cp:revision>
  <cp:lastPrinted>2021-04-23T12:48:59Z</cp:lastPrinted>
  <dcterms:created xsi:type="dcterms:W3CDTF">2019-05-17T07:50:07Z</dcterms:created>
  <dcterms:modified xsi:type="dcterms:W3CDTF">2021-05-21T21:17:36Z</dcterms:modified>
</cp:coreProperties>
</file>